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tif" ContentType="image/tif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E156E2E-1A22-44D7-A07D-883F0AF9B3A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936474F-DD5A-4EF4-990C-E7D96EE950D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B0ACE89-C64D-4A5D-B216-121665998C8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BAF0D72-5730-43FA-997C-6226CE7F02E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DAF2351-40F8-4424-8486-95364681369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24845D1-65EF-44E3-81AF-7CC842DC911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2215989-22CA-4E00-8048-C2336FD07AB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880BF9A-B01D-4590-A76B-FDB402C95F1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271C39E-1B61-4CB0-B3F7-AF06B86ED4B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13C17D8-34A5-4FFA-B4C7-75F8E3480A8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811370A-A854-4DC8-979C-C5903A0B490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B63A35D-8DB4-448E-A63A-DA72789DD07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4572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371600" indent="-4572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1828800" indent="-9144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F8645F3-6A6D-4F52-A164-C4551048F05A}"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ti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txBox="1"/>
          <p:nvPr/>
        </p:nvSpPr>
        <p:spPr>
          <a:xfrm>
            <a:off x="611280" y="5876640"/>
            <a:ext cx="8229600" cy="671400"/>
          </a:xfrm>
          <a:prstGeom prst="rect">
            <a:avLst/>
          </a:prstGeom>
          <a:noFill/>
          <a:ln w="0">
            <a:noFill/>
          </a:ln>
        </p:spPr>
        <p:txBody>
          <a:bodyPr lIns="90000" rIns="90000" tIns="46800" bIns="46800" anchor="t">
            <a:normAutofit/>
          </a:bodyPr>
          <a:p>
            <a:pPr algn="just">
              <a:lnSpc>
                <a:spcPct val="100000"/>
              </a:lnSpc>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Supplementary Figure S1. Correlation of FAM83 family gene expression levels with the tumor microenvironment. (A) Heatmap of FAM83s family genes associated with ImmuneScore. (B) ESTIMATEScore. (C) Tumor purity. The circle color indicates the correlation coefficient, red indicates a positive correlation, and blue indicates a negative correlation.</a:t>
            </a:r>
            <a:endParaRPr b="0" lang="en-US" sz="1200" spc="-1" strike="noStrike">
              <a:solidFill>
                <a:srgbClr val="000000"/>
              </a:solidFill>
              <a:latin typeface="Arial"/>
            </a:endParaRPr>
          </a:p>
        </p:txBody>
      </p:sp>
      <p:pic>
        <p:nvPicPr>
          <p:cNvPr id="42" name="图片 4" descr="Supplementary Figure S1 "/>
          <p:cNvPicPr/>
          <p:nvPr/>
        </p:nvPicPr>
        <p:blipFill>
          <a:blip r:embed="rId1"/>
          <a:stretch/>
        </p:blipFill>
        <p:spPr>
          <a:xfrm>
            <a:off x="1359000" y="103320"/>
            <a:ext cx="6256080" cy="581796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04-13T11:05:06Z</dcterms:created>
  <dc:creator>X</dc:creator>
  <dc:description/>
  <dc:language>en-US</dc:language>
  <cp:lastModifiedBy>太天真</cp:lastModifiedBy>
  <dcterms:modified xsi:type="dcterms:W3CDTF">2022-06-22T02:57:18Z</dcterms:modified>
  <cp:revision>2</cp:revision>
  <dc:subject/>
  <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ADE2219A212E4657B5DDDF543E85A5A1</vt:lpwstr>
  </property>
  <property fmtid="{D5CDD505-2E9C-101B-9397-08002B2CF9AE}" pid="3" name="KSOProductBuildVer">
    <vt:lpwstr>2052-11.1.0.11744</vt:lpwstr>
  </property>
</Properties>
</file>